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3" r:id="rId2"/>
  </p:sldIdLst>
  <p:sldSz cx="6858000" cy="9144000" type="screen4x3"/>
  <p:notesSz cx="6797675" cy="99250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00" userDrawn="1">
          <p15:clr>
            <a:srgbClr val="A4A3A4"/>
          </p15:clr>
        </p15:guide>
        <p15:guide id="2" pos="350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mey Redkar" initials="AR" lastIdx="8" clrIdx="0">
    <p:extLst>
      <p:ext uri="{19B8F6BF-5375-455C-9EA6-DF929625EA0E}">
        <p15:presenceInfo xmlns:p15="http://schemas.microsoft.com/office/powerpoint/2012/main" userId="S::ge2rerea@uco.es::31bd8819-4cbc-4ffd-9093-849e441bc21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BFC1"/>
    <a:srgbClr val="4E8F00"/>
    <a:srgbClr val="996633"/>
    <a:srgbClr val="FFD579"/>
    <a:srgbClr val="0000FF"/>
    <a:srgbClr val="0066FF"/>
    <a:srgbClr val="C9C39F"/>
    <a:srgbClr val="D2CDA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90" autoAdjust="0"/>
    <p:restoredTop sz="50000" autoAdjust="0"/>
  </p:normalViewPr>
  <p:slideViewPr>
    <p:cSldViewPr>
      <p:cViewPr>
        <p:scale>
          <a:sx n="114" d="100"/>
          <a:sy n="114" d="100"/>
        </p:scale>
        <p:origin x="2896" y="-1296"/>
      </p:cViewPr>
      <p:guideLst>
        <p:guide orient="horz" pos="2400"/>
        <p:guide pos="3504"/>
      </p:guideLst>
    </p:cSldViewPr>
  </p:slideViewPr>
  <p:outlineViewPr>
    <p:cViewPr>
      <p:scale>
        <a:sx n="33" d="100"/>
        <a:sy n="33" d="100"/>
      </p:scale>
      <p:origin x="246" y="351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60" cy="496253"/>
          </a:xfrm>
          <a:prstGeom prst="rect">
            <a:avLst/>
          </a:prstGeom>
        </p:spPr>
        <p:txBody>
          <a:bodyPr vert="horz" lIns="93848" tIns="46924" rIns="93848" bIns="46924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60" cy="496253"/>
          </a:xfrm>
          <a:prstGeom prst="rect">
            <a:avLst/>
          </a:prstGeom>
        </p:spPr>
        <p:txBody>
          <a:bodyPr vert="horz" lIns="93848" tIns="46924" rIns="93848" bIns="46924" rtlCol="0"/>
          <a:lstStyle>
            <a:lvl1pPr algn="r">
              <a:defRPr sz="1200"/>
            </a:lvl1pPr>
          </a:lstStyle>
          <a:p>
            <a:fld id="{BE8CF433-DC74-4B2D-9A03-C6AA1C7AF034}" type="datetimeFigureOut">
              <a:rPr lang="it-IT" smtClean="0"/>
              <a:pPr/>
              <a:t>23/03/21</a:t>
            </a:fld>
            <a:endParaRPr lang="it-IT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848" tIns="46924" rIns="93848" bIns="46924" rtlCol="0" anchor="ctr"/>
          <a:lstStyle/>
          <a:p>
            <a:endParaRPr lang="it-IT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768" y="4714399"/>
            <a:ext cx="5438140" cy="4466273"/>
          </a:xfrm>
          <a:prstGeom prst="rect">
            <a:avLst/>
          </a:prstGeom>
        </p:spPr>
        <p:txBody>
          <a:bodyPr vert="horz" lIns="93848" tIns="46924" rIns="93848" bIns="46924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it-IT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7075"/>
            <a:ext cx="2945660" cy="496253"/>
          </a:xfrm>
          <a:prstGeom prst="rect">
            <a:avLst/>
          </a:prstGeom>
        </p:spPr>
        <p:txBody>
          <a:bodyPr vert="horz" lIns="93848" tIns="46924" rIns="93848" bIns="46924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0443" y="9427075"/>
            <a:ext cx="2945660" cy="496253"/>
          </a:xfrm>
          <a:prstGeom prst="rect">
            <a:avLst/>
          </a:prstGeom>
        </p:spPr>
        <p:txBody>
          <a:bodyPr vert="horz" lIns="93848" tIns="46924" rIns="93848" bIns="46924" rtlCol="0" anchor="b"/>
          <a:lstStyle>
            <a:lvl1pPr algn="r">
              <a:defRPr sz="1200"/>
            </a:lvl1pPr>
          </a:lstStyle>
          <a:p>
            <a:fld id="{88998C2B-0B5C-4909-9A38-90164842D09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22160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F9216B-F4AD-4CA6-8AF7-D7A83C2288FB}" type="datetimeFigureOut">
              <a:rPr lang="en-US" smtClean="0"/>
              <a:pPr/>
              <a:t>3/2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3728A-F0A8-49AB-B73A-16BECF8E5F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227 Rectángulo">
            <a:extLst>
              <a:ext uri="{FF2B5EF4-FFF2-40B4-BE49-F238E27FC236}">
                <a16:creationId xmlns:a16="http://schemas.microsoft.com/office/drawing/2014/main" id="{539D0EDB-DFEE-4149-A32E-01EB9D1F2AA8}"/>
              </a:ext>
            </a:extLst>
          </p:cNvPr>
          <p:cNvSpPr/>
          <p:nvPr/>
        </p:nvSpPr>
        <p:spPr>
          <a:xfrm>
            <a:off x="24446" y="0"/>
            <a:ext cx="1180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ble. S2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1" name="Table 30">
            <a:extLst>
              <a:ext uri="{FF2B5EF4-FFF2-40B4-BE49-F238E27FC236}">
                <a16:creationId xmlns:a16="http://schemas.microsoft.com/office/drawing/2014/main" id="{004F9ABC-0972-F141-8B52-78E59FE551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7720884"/>
              </p:ext>
            </p:extLst>
          </p:nvPr>
        </p:nvGraphicFramePr>
        <p:xfrm>
          <a:off x="722272" y="1905000"/>
          <a:ext cx="5413456" cy="2768025"/>
        </p:xfrm>
        <a:graphic>
          <a:graphicData uri="http://schemas.openxmlformats.org/drawingml/2006/table">
            <a:tbl>
              <a:tblPr/>
              <a:tblGrid>
                <a:gridCol w="13998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306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01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014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3014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3014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553605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Nc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m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2v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7v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x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53605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-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(NS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53605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s-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(NS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(GS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53605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-0 </a:t>
                      </a:r>
                      <a:r>
                        <a:rPr lang="en-GB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r4-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(GS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53605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-0 </a:t>
                      </a:r>
                      <a:r>
                        <a:rPr lang="en-GB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r4b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 (NS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3C3A08C6-5FC1-B747-A845-F12D1BAFEDE2}"/>
              </a:ext>
            </a:extLst>
          </p:cNvPr>
          <p:cNvSpPr/>
          <p:nvPr/>
        </p:nvSpPr>
        <p:spPr>
          <a:xfrm>
            <a:off x="24446" y="8305800"/>
            <a:ext cx="659780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342900">
              <a:defRPr/>
            </a:pPr>
            <a:r>
              <a:rPr lang="en-GB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r>
              <a:rPr lang="en-GB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sistance and susceptibility of adult leaves of Arabidopsis lines to various </a:t>
            </a:r>
            <a:r>
              <a:rPr lang="en-GB" sz="1200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bugo</a:t>
            </a:r>
            <a:r>
              <a:rPr lang="en-GB" sz="1200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andida</a:t>
            </a:r>
            <a:r>
              <a:rPr lang="en-GB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races (GR = Green Resistance; NR = Necrotic Resistance; S = Susceptibility; NS = Necrotic Susceptibility; GS = Green Susceptibility)</a:t>
            </a:r>
            <a:endParaRPr lang="en-GB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63560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85</TotalTime>
  <Words>91</Words>
  <Application>Microsoft Macintosh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David</dc:creator>
  <cp:lastModifiedBy>Amey Redkar</cp:lastModifiedBy>
  <cp:revision>1262</cp:revision>
  <cp:lastPrinted>2020-06-23T17:03:15Z</cp:lastPrinted>
  <dcterms:created xsi:type="dcterms:W3CDTF">2015-07-20T15:30:42Z</dcterms:created>
  <dcterms:modified xsi:type="dcterms:W3CDTF">2021-03-23T05:37:54Z</dcterms:modified>
</cp:coreProperties>
</file>